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93"/>
    <p:restoredTop sz="94602"/>
  </p:normalViewPr>
  <p:slideViewPr>
    <p:cSldViewPr snapToGrid="0" snapToObjects="1">
      <p:cViewPr varScale="1">
        <p:scale>
          <a:sx n="62" d="100"/>
          <a:sy n="62" d="100"/>
        </p:scale>
        <p:origin x="224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40511-E0D2-8447-B6E8-494805BC30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0EB346-3612-694B-99D6-6EA25D963B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06470F-F62E-5149-ADDF-4A2613988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68E69-E3A1-5742-9BDA-5E3D07DD4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AE673-DFBD-964B-A22B-D51F6FE95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331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49BF3-591B-A84E-9DC6-186794E005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F61598-1737-9D47-B49F-7C0D9AF6E3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3BFA2-DD36-3E4C-B02D-A5F749419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3BA833-4DB0-DD46-94F3-C77D3F9F9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1AB9E7-0D78-4B42-817C-787612194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98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07AE49-BF7D-1642-891C-A4E104F69F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5742C6-2792-C44F-B647-D25B05CEE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D3D48F-6456-2E49-A737-CC36047E9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A1C183-9530-284D-B435-3B3FDDA34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1F904-C2D7-FC45-B128-C56D16723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432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25285-C388-9345-A270-3C7526C8B9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B6DEC7-5591-894A-A52C-AD5E0686EA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2B95E-8D63-8547-9910-264ECDA89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807DA4-266D-284E-88AD-2397F3318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3F420-C6ED-3945-8B24-BF61E8297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558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F3398-007F-E94F-B79F-8EB517F734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5F9D45-BB3B-F84C-8282-28281FB185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FC7A69-755E-DD4E-A545-FB4876BA3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3DC318-F7DF-4A43-8E2C-AFA0467E9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53720-5DB7-2241-92B6-AB66E10FB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13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0E1BC-5A48-4840-A189-077DDDDF2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B28150-3008-CB43-BF4F-82AFF9FD6B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BE6880-49CA-0D45-A742-51A428BB4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CE8216-864E-5E4D-983D-67C23B9ED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C38A0D-8756-7A49-AEF2-2E6DB28EA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502777-AE32-A345-AA4A-BE75E9C67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93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31F0A1-F10F-EB43-8955-58737309A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CF80F8-5BBA-3140-98E0-09157B04A0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411BE1-17A6-B548-9EDB-C57300681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DDAEB8-0510-8B4B-A4B0-45B544E544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273ADE-A9FD-0849-8A52-5305BA7E0C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7554BD-BCFF-314C-9AA7-64B92BD8E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CF9982-F285-344B-9B7E-0A63C6D87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8EFCAC-1E4A-5346-AC6C-D8775F221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135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59DE99-13FA-304F-B6F0-B67E59571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820210-0C89-3D41-B8A9-CCF8AB93F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BB850B-813A-A943-B61B-E7CC968DA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816B20-4A69-1C44-BFAB-ED9AD1D0C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441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2903AD-AE47-D14B-B46B-9FADBD98F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926A34-76D3-434A-A570-D3721608B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46A791-02AC-EF46-B5B6-F76D33A67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00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A97760-F2EB-4E42-9285-95683FE77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F8334A-28A5-7844-B7DE-61E442DCA4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2C469C-531C-D449-8F82-4CBBDC2944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16A541-893A-8C4F-A97C-F67046586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4C5D7-EF52-8E4D-B11F-A6B886328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0315A7-AD87-D446-829B-18685654B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13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041E4-7418-984D-B368-1FB72BDE66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3A27AA-CFA3-6748-ACFA-4804435C3C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5A5CD4-0D0E-7C46-83B5-F42654333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16CBE3-A926-A544-988A-63A2DB27C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646ED6-1DC7-F342-A2FD-75463C0F5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D779C1-46F5-0043-ABEF-FDCC74FA7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022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EF3D7C-32BB-2D4F-AF53-BFBBF99CA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4EAD6F-34A3-A34E-9C92-E8DF5CECBC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FD80E8-ED73-D04E-8C85-A69795BCB9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15BE3-2652-5043-8A7D-DEE57A4EDB51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2F71AA-8B91-CA4E-BB21-883B3D8967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B70372-B04A-C44C-A49E-88DA32E87A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F64B8-2BB4-334C-A593-09D626803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769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5F0FB-9849-D845-8FCB-9747C58B79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02170"/>
            <a:ext cx="10515600" cy="4351338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Supplementary Video for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The first record of exceptionally-preserved spiral coprolites from the </a:t>
            </a:r>
            <a:r>
              <a:rPr lang="en-US" dirty="0" err="1"/>
              <a:t>Tsagan-Tsab</a:t>
            </a:r>
            <a:r>
              <a:rPr lang="en-US" dirty="0"/>
              <a:t> Formation (Lower Cretaceous), </a:t>
            </a:r>
            <a:r>
              <a:rPr lang="en-US" dirty="0" err="1"/>
              <a:t>Tatal</a:t>
            </a:r>
            <a:r>
              <a:rPr lang="en-US" dirty="0"/>
              <a:t>, western Mongolia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Paul Rummy, Kazim </a:t>
            </a:r>
            <a:r>
              <a:rPr lang="en-US" dirty="0" err="1"/>
              <a:t>Halaclar</a:t>
            </a:r>
            <a:r>
              <a:rPr lang="en-US" dirty="0"/>
              <a:t> &amp; He Chen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1905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5E9F4-A54C-BA48-8E27-953979C2EC5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8DF854-BD25-2042-AAC3-D39224ADFD0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Supplemental Video_Spiral Ms.mov">
            <a:hlinkClick r:id="" action="ppaction://media"/>
            <a:extLst>
              <a:ext uri="{FF2B5EF4-FFF2-40B4-BE49-F238E27FC236}">
                <a16:creationId xmlns:a16="http://schemas.microsoft.com/office/drawing/2014/main" id="{5123EE6A-F5B8-1A4F-BCD8-FD4A7374D58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9171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1</Words>
  <Application>Microsoft Macintosh PowerPoint</Application>
  <PresentationFormat>Widescreen</PresentationFormat>
  <Paragraphs>6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Rummy</dc:creator>
  <cp:lastModifiedBy>Paul Rummy</cp:lastModifiedBy>
  <cp:revision>2</cp:revision>
  <dcterms:created xsi:type="dcterms:W3CDTF">2021-02-26T09:09:16Z</dcterms:created>
  <dcterms:modified xsi:type="dcterms:W3CDTF">2021-02-26T09:36:00Z</dcterms:modified>
</cp:coreProperties>
</file>